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08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61" d="100"/>
          <a:sy n="161" d="100"/>
        </p:scale>
        <p:origin x="-36" y="-603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as Roos" userId="80ed2b38bc7399a1" providerId="LiveId" clId="{9472E30D-AD58-4361-9725-713692A83D57}"/>
  </pc:docChgLst>
  <pc:docChgLst>
    <pc:chgData name="Andreas Roos" userId="80ed2b38bc7399a1" providerId="LiveId" clId="{F8540C7F-5C35-4CD2-A1D3-58C7D5FF5781}"/>
    <pc:docChg chg="undo custSel modSld">
      <pc:chgData name="Andreas Roos" userId="80ed2b38bc7399a1" providerId="LiveId" clId="{F8540C7F-5C35-4CD2-A1D3-58C7D5FF5781}" dt="2018-06-03T20:26:13.817" v="1487" actId="14861"/>
      <pc:docMkLst>
        <pc:docMk/>
      </pc:docMkLst>
      <pc:sldChg chg="addSp delSp modSp">
        <pc:chgData name="Andreas Roos" userId="80ed2b38bc7399a1" providerId="LiveId" clId="{F8540C7F-5C35-4CD2-A1D3-58C7D5FF5781}" dt="2018-06-03T20:26:13.817" v="1487" actId="14861"/>
        <pc:sldMkLst>
          <pc:docMk/>
          <pc:sldMk cId="4032495362" sldId="264"/>
        </pc:sldMkLst>
        <pc:spChg chg="add del mod">
          <ac:chgData name="Andreas Roos" userId="80ed2b38bc7399a1" providerId="LiveId" clId="{F8540C7F-5C35-4CD2-A1D3-58C7D5FF5781}" dt="2018-05-31T19:01:00.177" v="409" actId="478"/>
          <ac:spMkLst>
            <pc:docMk/>
            <pc:sldMk cId="4032495362" sldId="264"/>
            <ac:spMk id="4" creationId="{EC8BBF68-E506-4771-A9FC-45328CA4FEDA}"/>
          </ac:spMkLst>
        </pc:spChg>
        <pc:spChg chg="del">
          <ac:chgData name="Andreas Roos" userId="80ed2b38bc7399a1" providerId="LiveId" clId="{F8540C7F-5C35-4CD2-A1D3-58C7D5FF5781}" dt="2018-05-31T18:46:47.707" v="0" actId="478"/>
          <ac:spMkLst>
            <pc:docMk/>
            <pc:sldMk cId="4032495362" sldId="264"/>
            <ac:spMk id="13" creationId="{00000000-0000-0000-0000-000000000000}"/>
          </ac:spMkLst>
        </pc:spChg>
        <pc:spChg chg="add mod">
          <ac:chgData name="Andreas Roos" userId="80ed2b38bc7399a1" providerId="LiveId" clId="{F8540C7F-5C35-4CD2-A1D3-58C7D5FF5781}" dt="2018-06-02T21:59:11.825" v="1368" actId="1036"/>
          <ac:spMkLst>
            <pc:docMk/>
            <pc:sldMk cId="4032495362" sldId="264"/>
            <ac:spMk id="18" creationId="{DB1D918D-9199-4B07-999A-982AB5C61B04}"/>
          </ac:spMkLst>
        </pc:spChg>
        <pc:spChg chg="add mod">
          <ac:chgData name="Andreas Roos" userId="80ed2b38bc7399a1" providerId="LiveId" clId="{F8540C7F-5C35-4CD2-A1D3-58C7D5FF5781}" dt="2018-05-31T19:07:27.688" v="691" actId="20577"/>
          <ac:spMkLst>
            <pc:docMk/>
            <pc:sldMk cId="4032495362" sldId="264"/>
            <ac:spMk id="27" creationId="{F3FDF542-40B6-4849-8B32-DD3A2FB3BCAD}"/>
          </ac:spMkLst>
        </pc:spChg>
        <pc:spChg chg="add mod">
          <ac:chgData name="Andreas Roos" userId="80ed2b38bc7399a1" providerId="LiveId" clId="{F8540C7F-5C35-4CD2-A1D3-58C7D5FF5781}" dt="2018-05-31T19:13:19.703" v="930" actId="14100"/>
          <ac:spMkLst>
            <pc:docMk/>
            <pc:sldMk cId="4032495362" sldId="264"/>
            <ac:spMk id="29" creationId="{9808567C-6BF2-4A47-AF54-ACC1C2C9DDBD}"/>
          </ac:spMkLst>
        </pc:spChg>
        <pc:spChg chg="add mod">
          <ac:chgData name="Andreas Roos" userId="80ed2b38bc7399a1" providerId="LiveId" clId="{F8540C7F-5C35-4CD2-A1D3-58C7D5FF5781}" dt="2018-06-02T22:00:40.849" v="1410" actId="20577"/>
          <ac:spMkLst>
            <pc:docMk/>
            <pc:sldMk cId="4032495362" sldId="264"/>
            <ac:spMk id="32" creationId="{A45EA9BB-5A64-4548-AC60-ED9F4F25FDDB}"/>
          </ac:spMkLst>
        </pc:spChg>
        <pc:spChg chg="mod">
          <ac:chgData name="Andreas Roos" userId="80ed2b38bc7399a1" providerId="LiveId" clId="{F8540C7F-5C35-4CD2-A1D3-58C7D5FF5781}" dt="2018-05-31T19:16:58.158" v="1267" actId="20577"/>
          <ac:spMkLst>
            <pc:docMk/>
            <pc:sldMk cId="4032495362" sldId="264"/>
            <ac:spMk id="74" creationId="{8DDF35D0-4D1F-4A56-B630-660E0BE73EA7}"/>
          </ac:spMkLst>
        </pc:spChg>
        <pc:spChg chg="mod">
          <ac:chgData name="Andreas Roos" userId="80ed2b38bc7399a1" providerId="LiveId" clId="{F8540C7F-5C35-4CD2-A1D3-58C7D5FF5781}" dt="2018-05-31T18:58:40.547" v="319" actId="1038"/>
          <ac:spMkLst>
            <pc:docMk/>
            <pc:sldMk cId="4032495362" sldId="264"/>
            <ac:spMk id="77" creationId="{8D636F03-3DAB-42D2-BBA9-C1E4AF290683}"/>
          </ac:spMkLst>
        </pc:spChg>
        <pc:spChg chg="mod">
          <ac:chgData name="Andreas Roos" userId="80ed2b38bc7399a1" providerId="LiveId" clId="{F8540C7F-5C35-4CD2-A1D3-58C7D5FF5781}" dt="2018-05-31T18:58:40.547" v="319" actId="1038"/>
          <ac:spMkLst>
            <pc:docMk/>
            <pc:sldMk cId="4032495362" sldId="264"/>
            <ac:spMk id="78" creationId="{4E87638A-D35F-4835-8DE3-239AFCC705C0}"/>
          </ac:spMkLst>
        </pc:spChg>
        <pc:spChg chg="mod">
          <ac:chgData name="Andreas Roos" userId="80ed2b38bc7399a1" providerId="LiveId" clId="{F8540C7F-5C35-4CD2-A1D3-58C7D5FF5781}" dt="2018-06-02T21:58:46.293" v="1338" actId="14100"/>
          <ac:spMkLst>
            <pc:docMk/>
            <pc:sldMk cId="4032495362" sldId="264"/>
            <ac:spMk id="79" creationId="{D22CB59F-7B92-49D5-AC54-AB753476E47B}"/>
          </ac:spMkLst>
        </pc:spChg>
        <pc:spChg chg="mod">
          <ac:chgData name="Andreas Roos" userId="80ed2b38bc7399a1" providerId="LiveId" clId="{F8540C7F-5C35-4CD2-A1D3-58C7D5FF5781}" dt="2018-05-31T18:58:40.547" v="319" actId="1038"/>
          <ac:spMkLst>
            <pc:docMk/>
            <pc:sldMk cId="4032495362" sldId="264"/>
            <ac:spMk id="82" creationId="{1CEE8486-9A53-49A9-92B4-36D65E73D37E}"/>
          </ac:spMkLst>
        </pc:spChg>
        <pc:spChg chg="mod">
          <ac:chgData name="Andreas Roos" userId="80ed2b38bc7399a1" providerId="LiveId" clId="{F8540C7F-5C35-4CD2-A1D3-58C7D5FF5781}" dt="2018-05-31T18:58:40.547" v="319" actId="1038"/>
          <ac:spMkLst>
            <pc:docMk/>
            <pc:sldMk cId="4032495362" sldId="264"/>
            <ac:spMk id="83" creationId="{672CB71E-DFCD-4342-A5E0-1EB205D3B4E6}"/>
          </ac:spMkLst>
        </pc:spChg>
        <pc:cxnChg chg="add del mod">
          <ac:chgData name="Andreas Roos" userId="80ed2b38bc7399a1" providerId="LiveId" clId="{F8540C7F-5C35-4CD2-A1D3-58C7D5FF5781}" dt="2018-06-02T21:39:08.449" v="1297" actId="478"/>
          <ac:cxnSpMkLst>
            <pc:docMk/>
            <pc:sldMk cId="4032495362" sldId="264"/>
            <ac:cxnSpMk id="3" creationId="{B556A9D8-967C-4444-BF81-03BA4E316DFB}"/>
          </ac:cxnSpMkLst>
        </pc:cxnChg>
        <pc:cxnChg chg="add mod">
          <ac:chgData name="Andreas Roos" userId="80ed2b38bc7399a1" providerId="LiveId" clId="{F8540C7F-5C35-4CD2-A1D3-58C7D5FF5781}" dt="2018-06-03T20:26:13.817" v="1487" actId="14861"/>
          <ac:cxnSpMkLst>
            <pc:docMk/>
            <pc:sldMk cId="4032495362" sldId="264"/>
            <ac:cxnSpMk id="4" creationId="{77B9FAB1-596F-47DF-929C-E8BA5BD9A867}"/>
          </ac:cxnSpMkLst>
        </pc:cxnChg>
        <pc:cxnChg chg="add del mod">
          <ac:chgData name="Andreas Roos" userId="80ed2b38bc7399a1" providerId="LiveId" clId="{F8540C7F-5C35-4CD2-A1D3-58C7D5FF5781}" dt="2018-05-31T19:17:44.198" v="1277" actId="478"/>
          <ac:cxnSpMkLst>
            <pc:docMk/>
            <pc:sldMk cId="4032495362" sldId="264"/>
            <ac:cxnSpMk id="11" creationId="{4B1E44DC-8D3F-46CC-A15E-6F7E37826D68}"/>
          </ac:cxnSpMkLst>
        </pc:cxnChg>
        <pc:cxnChg chg="add mod">
          <ac:chgData name="Andreas Roos" userId="80ed2b38bc7399a1" providerId="LiveId" clId="{F8540C7F-5C35-4CD2-A1D3-58C7D5FF5781}" dt="2018-06-02T21:59:06.881" v="1361" actId="1035"/>
          <ac:cxnSpMkLst>
            <pc:docMk/>
            <pc:sldMk cId="4032495362" sldId="264"/>
            <ac:cxnSpMk id="19" creationId="{71C18920-29B7-4B4C-88FD-44D61C65D7F4}"/>
          </ac:cxnSpMkLst>
        </pc:cxnChg>
        <pc:cxnChg chg="add mod">
          <ac:chgData name="Andreas Roos" userId="80ed2b38bc7399a1" providerId="LiveId" clId="{F8540C7F-5C35-4CD2-A1D3-58C7D5FF5781}" dt="2018-06-03T20:25:51.951" v="1486" actId="14100"/>
          <ac:cxnSpMkLst>
            <pc:docMk/>
            <pc:sldMk cId="4032495362" sldId="264"/>
            <ac:cxnSpMk id="20" creationId="{3788FD14-19F1-45E7-AAF8-63730C1DDDFF}"/>
          </ac:cxnSpMkLst>
        </pc:cxnChg>
        <pc:cxnChg chg="add mod">
          <ac:chgData name="Andreas Roos" userId="80ed2b38bc7399a1" providerId="LiveId" clId="{F8540C7F-5C35-4CD2-A1D3-58C7D5FF5781}" dt="2018-05-31T19:06:47.882" v="651" actId="14100"/>
          <ac:cxnSpMkLst>
            <pc:docMk/>
            <pc:sldMk cId="4032495362" sldId="264"/>
            <ac:cxnSpMk id="24" creationId="{78C208BC-B1D9-489F-9D61-0ABE59E2768D}"/>
          </ac:cxnSpMkLst>
        </pc:cxnChg>
        <pc:cxnChg chg="add del mod">
          <ac:chgData name="Andreas Roos" userId="80ed2b38bc7399a1" providerId="LiveId" clId="{F8540C7F-5C35-4CD2-A1D3-58C7D5FF5781}" dt="2018-06-03T20:25:33.593" v="1484" actId="478"/>
          <ac:cxnSpMkLst>
            <pc:docMk/>
            <pc:sldMk cId="4032495362" sldId="264"/>
            <ac:cxnSpMk id="25" creationId="{F9E1EDCC-8043-4798-86B6-97A19D53B3C1}"/>
          </ac:cxnSpMkLst>
        </pc:cxnChg>
        <pc:cxnChg chg="add mod">
          <ac:chgData name="Andreas Roos" userId="80ed2b38bc7399a1" providerId="LiveId" clId="{F8540C7F-5C35-4CD2-A1D3-58C7D5FF5781}" dt="2018-05-31T19:08:15.420" v="694" actId="1035"/>
          <ac:cxnSpMkLst>
            <pc:docMk/>
            <pc:sldMk cId="4032495362" sldId="264"/>
            <ac:cxnSpMk id="28" creationId="{A73F7CA7-BBC3-4E77-947E-31BE17D2B35C}"/>
          </ac:cxnSpMkLst>
        </pc:cxnChg>
        <pc:cxnChg chg="add del mod">
          <ac:chgData name="Andreas Roos" userId="80ed2b38bc7399a1" providerId="LiveId" clId="{F8540C7F-5C35-4CD2-A1D3-58C7D5FF5781}" dt="2018-06-03T20:25:35.676" v="1485" actId="478"/>
          <ac:cxnSpMkLst>
            <pc:docMk/>
            <pc:sldMk cId="4032495362" sldId="264"/>
            <ac:cxnSpMk id="30" creationId="{B8A1631A-0CDC-4179-94BD-5EFC0CA1F5F1}"/>
          </ac:cxnSpMkLst>
        </pc:cxnChg>
        <pc:cxnChg chg="add mod">
          <ac:chgData name="Andreas Roos" userId="80ed2b38bc7399a1" providerId="LiveId" clId="{F8540C7F-5C35-4CD2-A1D3-58C7D5FF5781}" dt="2018-05-31T19:13:52.271" v="1094" actId="1035"/>
          <ac:cxnSpMkLst>
            <pc:docMk/>
            <pc:sldMk cId="4032495362" sldId="264"/>
            <ac:cxnSpMk id="33" creationId="{F7F39EA2-90A9-4D62-ABA7-89536A5FD3DF}"/>
          </ac:cxnSpMkLst>
        </pc:cxnChg>
        <pc:cxnChg chg="add mod">
          <ac:chgData name="Andreas Roos" userId="80ed2b38bc7399a1" providerId="LiveId" clId="{F8540C7F-5C35-4CD2-A1D3-58C7D5FF5781}" dt="2018-06-03T20:26:13.817" v="1487" actId="14861"/>
          <ac:cxnSpMkLst>
            <pc:docMk/>
            <pc:sldMk cId="4032495362" sldId="264"/>
            <ac:cxnSpMk id="34" creationId="{13F68208-CBC4-4282-88C6-45416C3FEE7A}"/>
          </ac:cxnSpMkLst>
        </pc:cxnChg>
        <pc:cxnChg chg="mod">
          <ac:chgData name="Andreas Roos" userId="80ed2b38bc7399a1" providerId="LiveId" clId="{F8540C7F-5C35-4CD2-A1D3-58C7D5FF5781}" dt="2018-05-31T18:58:40.547" v="319" actId="1038"/>
          <ac:cxnSpMkLst>
            <pc:docMk/>
            <pc:sldMk cId="4032495362" sldId="264"/>
            <ac:cxnSpMk id="75" creationId="{6B3DE9BA-6D3B-4291-9AA5-679FFE787769}"/>
          </ac:cxnSpMkLst>
        </pc:cxnChg>
        <pc:cxnChg chg="mod">
          <ac:chgData name="Andreas Roos" userId="80ed2b38bc7399a1" providerId="LiveId" clId="{F8540C7F-5C35-4CD2-A1D3-58C7D5FF5781}" dt="2018-05-31T18:58:40.547" v="319" actId="1038"/>
          <ac:cxnSpMkLst>
            <pc:docMk/>
            <pc:sldMk cId="4032495362" sldId="264"/>
            <ac:cxnSpMk id="76" creationId="{399077D8-4C0D-46A3-B801-2B8F3249C5FA}"/>
          </ac:cxnSpMkLst>
        </pc:cxnChg>
        <pc:cxnChg chg="mod">
          <ac:chgData name="Andreas Roos" userId="80ed2b38bc7399a1" providerId="LiveId" clId="{F8540C7F-5C35-4CD2-A1D3-58C7D5FF5781}" dt="2018-05-31T18:58:40.547" v="319" actId="1038"/>
          <ac:cxnSpMkLst>
            <pc:docMk/>
            <pc:sldMk cId="4032495362" sldId="264"/>
            <ac:cxnSpMk id="80" creationId="{9E9A8452-157A-46BC-B39C-9CFE19051F87}"/>
          </ac:cxnSpMkLst>
        </pc:cxnChg>
        <pc:cxnChg chg="del mod">
          <ac:chgData name="Andreas Roos" userId="80ed2b38bc7399a1" providerId="LiveId" clId="{F8540C7F-5C35-4CD2-A1D3-58C7D5FF5781}" dt="2018-05-31T18:58:01.575" v="266" actId="478"/>
          <ac:cxnSpMkLst>
            <pc:docMk/>
            <pc:sldMk cId="4032495362" sldId="264"/>
            <ac:cxnSpMk id="81" creationId="{5C1BAF20-14A4-41E4-9932-CEE5373E7D73}"/>
          </ac:cxnSpMkLst>
        </pc:cxnChg>
        <pc:cxnChg chg="mod">
          <ac:chgData name="Andreas Roos" userId="80ed2b38bc7399a1" providerId="LiveId" clId="{F8540C7F-5C35-4CD2-A1D3-58C7D5FF5781}" dt="2018-05-31T18:58:40.547" v="319" actId="1038"/>
          <ac:cxnSpMkLst>
            <pc:docMk/>
            <pc:sldMk cId="4032495362" sldId="264"/>
            <ac:cxnSpMk id="84" creationId="{80CC5045-4F4F-4CBA-8C94-C7E4EB686C3A}"/>
          </ac:cxnSpMkLst>
        </pc:cxnChg>
        <pc:cxnChg chg="mod">
          <ac:chgData name="Andreas Roos" userId="80ed2b38bc7399a1" providerId="LiveId" clId="{F8540C7F-5C35-4CD2-A1D3-58C7D5FF5781}" dt="2018-05-31T18:58:40.547" v="319" actId="1038"/>
          <ac:cxnSpMkLst>
            <pc:docMk/>
            <pc:sldMk cId="4032495362" sldId="264"/>
            <ac:cxnSpMk id="85" creationId="{213B734D-FCD1-4BE3-9923-6D7E759A95D2}"/>
          </ac:cxnSpMkLst>
        </pc:cxnChg>
      </pc:sldChg>
    </pc:docChg>
  </pc:docChgLst>
  <pc:docChgLst>
    <pc:chgData name="TO ROLL" userId="8681d8a9158f669a" providerId="LiveId" clId="{D6166876-5199-4924-8202-32988320D758}"/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6487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850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676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9939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950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449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5379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6056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472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2785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9515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511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feld 3">
            <a:extLst>
              <a:ext uri="{FF2B5EF4-FFF2-40B4-BE49-F238E27FC236}">
                <a16:creationId xmlns:a16="http://schemas.microsoft.com/office/drawing/2014/main" id="{8DDF35D0-4D1F-4A56-B630-660E0BE73EA7}"/>
              </a:ext>
            </a:extLst>
          </p:cNvPr>
          <p:cNvSpPr txBox="1"/>
          <p:nvPr/>
        </p:nvSpPr>
        <p:spPr>
          <a:xfrm>
            <a:off x="544963" y="1407865"/>
            <a:ext cx="5919467" cy="352355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V3 WT-p.P104L dimerization &amp; mis-localization to the Golgi</a:t>
            </a:r>
            <a:endParaRPr lang="de-DE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75" name="Gerade Verbindung mit Pfeil 74">
            <a:extLst>
              <a:ext uri="{FF2B5EF4-FFF2-40B4-BE49-F238E27FC236}">
                <a16:creationId xmlns:a16="http://schemas.microsoft.com/office/drawing/2014/main" id="{6B3DE9BA-6D3B-4291-9AA5-679FFE787769}"/>
              </a:ext>
            </a:extLst>
          </p:cNvPr>
          <p:cNvCxnSpPr>
            <a:cxnSpLocks/>
          </p:cNvCxnSpPr>
          <p:nvPr/>
        </p:nvCxnSpPr>
        <p:spPr>
          <a:xfrm>
            <a:off x="1387609" y="1759268"/>
            <a:ext cx="0" cy="5775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 Verbindung mit Pfeil 75">
            <a:extLst>
              <a:ext uri="{FF2B5EF4-FFF2-40B4-BE49-F238E27FC236}">
                <a16:creationId xmlns:a16="http://schemas.microsoft.com/office/drawing/2014/main" id="{399077D8-4C0D-46A3-B801-2B8F3249C5FA}"/>
              </a:ext>
            </a:extLst>
          </p:cNvPr>
          <p:cNvCxnSpPr>
            <a:cxnSpLocks/>
          </p:cNvCxnSpPr>
          <p:nvPr/>
        </p:nvCxnSpPr>
        <p:spPr>
          <a:xfrm>
            <a:off x="3504699" y="1759268"/>
            <a:ext cx="0" cy="5775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feld 7">
            <a:extLst>
              <a:ext uri="{FF2B5EF4-FFF2-40B4-BE49-F238E27FC236}">
                <a16:creationId xmlns:a16="http://schemas.microsoft.com/office/drawing/2014/main" id="{8D636F03-3DAB-42D2-BBA9-C1E4AF290683}"/>
              </a:ext>
            </a:extLst>
          </p:cNvPr>
          <p:cNvSpPr txBox="1"/>
          <p:nvPr/>
        </p:nvSpPr>
        <p:spPr>
          <a:xfrm>
            <a:off x="544964" y="2336800"/>
            <a:ext cx="1685290" cy="550545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V3 absence at the sarcolemma</a:t>
            </a:r>
            <a:endParaRPr lang="de-DE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8" name="Textfeld 8">
            <a:extLst>
              <a:ext uri="{FF2B5EF4-FFF2-40B4-BE49-F238E27FC236}">
                <a16:creationId xmlns:a16="http://schemas.microsoft.com/office/drawing/2014/main" id="{4E87638A-D35F-4835-8DE3-239AFCC705C0}"/>
              </a:ext>
            </a:extLst>
          </p:cNvPr>
          <p:cNvSpPr txBox="1"/>
          <p:nvPr/>
        </p:nvSpPr>
        <p:spPr>
          <a:xfrm>
            <a:off x="2662054" y="2336800"/>
            <a:ext cx="1685290" cy="550545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sistant</a:t>
            </a:r>
            <a:r>
              <a:rPr lang="de-DE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R-Golgi stress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9" name="Textfeld 9">
            <a:extLst>
              <a:ext uri="{FF2B5EF4-FFF2-40B4-BE49-F238E27FC236}">
                <a16:creationId xmlns:a16="http://schemas.microsoft.com/office/drawing/2014/main" id="{D22CB59F-7B92-49D5-AC54-AB753476E47B}"/>
              </a:ext>
            </a:extLst>
          </p:cNvPr>
          <p:cNvSpPr txBox="1"/>
          <p:nvPr/>
        </p:nvSpPr>
        <p:spPr>
          <a:xfrm>
            <a:off x="2589372" y="5222766"/>
            <a:ext cx="1821368" cy="1729738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ection of a variety of proteins including mitochondrial, cytoskeletal and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rcolemmal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teins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0" name="Gerade Verbindung mit Pfeil 79">
            <a:extLst>
              <a:ext uri="{FF2B5EF4-FFF2-40B4-BE49-F238E27FC236}">
                <a16:creationId xmlns:a16="http://schemas.microsoft.com/office/drawing/2014/main" id="{9E9A8452-157A-46BC-B39C-9CFE19051F87}"/>
              </a:ext>
            </a:extLst>
          </p:cNvPr>
          <p:cNvCxnSpPr>
            <a:cxnSpLocks/>
          </p:cNvCxnSpPr>
          <p:nvPr/>
        </p:nvCxnSpPr>
        <p:spPr>
          <a:xfrm>
            <a:off x="3504699" y="2887345"/>
            <a:ext cx="0" cy="60261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feld 13">
            <a:extLst>
              <a:ext uri="{FF2B5EF4-FFF2-40B4-BE49-F238E27FC236}">
                <a16:creationId xmlns:a16="http://schemas.microsoft.com/office/drawing/2014/main" id="{1CEE8486-9A53-49A9-92B4-36D65E73D37E}"/>
              </a:ext>
            </a:extLst>
          </p:cNvPr>
          <p:cNvSpPr txBox="1"/>
          <p:nvPr/>
        </p:nvSpPr>
        <p:spPr>
          <a:xfrm>
            <a:off x="544964" y="3489959"/>
            <a:ext cx="1685290" cy="610986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rcolemmal</a:t>
            </a:r>
            <a:r>
              <a:rPr lang="de-DE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ulnerability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3" name="Textfeld 14">
            <a:extLst>
              <a:ext uri="{FF2B5EF4-FFF2-40B4-BE49-F238E27FC236}">
                <a16:creationId xmlns:a16="http://schemas.microsoft.com/office/drawing/2014/main" id="{672CB71E-DFCD-4342-A5E0-1EB205D3B4E6}"/>
              </a:ext>
            </a:extLst>
          </p:cNvPr>
          <p:cNvSpPr txBox="1"/>
          <p:nvPr/>
        </p:nvSpPr>
        <p:spPr>
          <a:xfrm>
            <a:off x="2657410" y="3493026"/>
            <a:ext cx="1685290" cy="1096009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uild up of protein aggregates (ubiquitin and p62-positive)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4" name="Gerade Verbindung mit Pfeil 83">
            <a:extLst>
              <a:ext uri="{FF2B5EF4-FFF2-40B4-BE49-F238E27FC236}">
                <a16:creationId xmlns:a16="http://schemas.microsoft.com/office/drawing/2014/main" id="{80CC5045-4F4F-4CBA-8C94-C7E4EB686C3A}"/>
              </a:ext>
            </a:extLst>
          </p:cNvPr>
          <p:cNvCxnSpPr>
            <a:cxnSpLocks/>
          </p:cNvCxnSpPr>
          <p:nvPr/>
        </p:nvCxnSpPr>
        <p:spPr>
          <a:xfrm>
            <a:off x="3500055" y="4593916"/>
            <a:ext cx="0" cy="6026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84">
            <a:extLst>
              <a:ext uri="{FF2B5EF4-FFF2-40B4-BE49-F238E27FC236}">
                <a16:creationId xmlns:a16="http://schemas.microsoft.com/office/drawing/2014/main" id="{213B734D-FCD1-4BE3-9923-6D7E759A95D2}"/>
              </a:ext>
            </a:extLst>
          </p:cNvPr>
          <p:cNvCxnSpPr>
            <a:cxnSpLocks/>
            <a:stCxn id="77" idx="2"/>
            <a:endCxn id="82" idx="0"/>
          </p:cNvCxnSpPr>
          <p:nvPr/>
        </p:nvCxnSpPr>
        <p:spPr>
          <a:xfrm>
            <a:off x="1387609" y="2887345"/>
            <a:ext cx="0" cy="6026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3">
            <a:extLst>
              <a:ext uri="{FF2B5EF4-FFF2-40B4-BE49-F238E27FC236}">
                <a16:creationId xmlns:a16="http://schemas.microsoft.com/office/drawing/2014/main" id="{DB1D918D-9199-4B07-999A-982AB5C61B04}"/>
              </a:ext>
            </a:extLst>
          </p:cNvPr>
          <p:cNvSpPr txBox="1"/>
          <p:nvPr/>
        </p:nvSpPr>
        <p:spPr>
          <a:xfrm>
            <a:off x="542383" y="7576904"/>
            <a:ext cx="3800313" cy="352355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ltra-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uctural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ndings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71C18920-29B7-4B4C-88FD-44D61C65D7F4}"/>
              </a:ext>
            </a:extLst>
          </p:cNvPr>
          <p:cNvCxnSpPr>
            <a:cxnSpLocks/>
          </p:cNvCxnSpPr>
          <p:nvPr/>
        </p:nvCxnSpPr>
        <p:spPr>
          <a:xfrm>
            <a:off x="3500365" y="6956859"/>
            <a:ext cx="0" cy="6026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>
            <a:extLst>
              <a:ext uri="{FF2B5EF4-FFF2-40B4-BE49-F238E27FC236}">
                <a16:creationId xmlns:a16="http://schemas.microsoft.com/office/drawing/2014/main" id="{3788FD14-19F1-45E7-AAF8-63730C1DDDFF}"/>
              </a:ext>
            </a:extLst>
          </p:cNvPr>
          <p:cNvCxnSpPr>
            <a:cxnSpLocks/>
            <a:stCxn id="82" idx="2"/>
          </p:cNvCxnSpPr>
          <p:nvPr/>
        </p:nvCxnSpPr>
        <p:spPr>
          <a:xfrm>
            <a:off x="1387609" y="4100945"/>
            <a:ext cx="0" cy="345852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78C208BC-B1D9-489F-9D61-0ABE59E2768D}"/>
              </a:ext>
            </a:extLst>
          </p:cNvPr>
          <p:cNvCxnSpPr>
            <a:cxnSpLocks/>
          </p:cNvCxnSpPr>
          <p:nvPr/>
        </p:nvCxnSpPr>
        <p:spPr>
          <a:xfrm flipV="1">
            <a:off x="4374644" y="2612072"/>
            <a:ext cx="404500" cy="98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8">
            <a:extLst>
              <a:ext uri="{FF2B5EF4-FFF2-40B4-BE49-F238E27FC236}">
                <a16:creationId xmlns:a16="http://schemas.microsoft.com/office/drawing/2014/main" id="{F3FDF542-40B6-4849-8B32-DD3A2FB3BCAD}"/>
              </a:ext>
            </a:extLst>
          </p:cNvPr>
          <p:cNvSpPr txBox="1"/>
          <p:nvPr/>
        </p:nvSpPr>
        <p:spPr>
          <a:xfrm>
            <a:off x="4779144" y="2318631"/>
            <a:ext cx="1685290" cy="550545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turbed</a:t>
            </a:r>
            <a:r>
              <a:rPr lang="de-DE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</a:t>
            </a:r>
            <a:r>
              <a:rPr lang="de-DE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cessing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A73F7CA7-BBC3-4E77-947E-31BE17D2B35C}"/>
              </a:ext>
            </a:extLst>
          </p:cNvPr>
          <p:cNvCxnSpPr>
            <a:cxnSpLocks/>
          </p:cNvCxnSpPr>
          <p:nvPr/>
        </p:nvCxnSpPr>
        <p:spPr>
          <a:xfrm>
            <a:off x="5594184" y="2875313"/>
            <a:ext cx="0" cy="60261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13">
            <a:extLst>
              <a:ext uri="{FF2B5EF4-FFF2-40B4-BE49-F238E27FC236}">
                <a16:creationId xmlns:a16="http://schemas.microsoft.com/office/drawing/2014/main" id="{9808567C-6BF2-4A47-AF54-ACC1C2C9DDBD}"/>
              </a:ext>
            </a:extLst>
          </p:cNvPr>
          <p:cNvSpPr txBox="1"/>
          <p:nvPr/>
        </p:nvSpPr>
        <p:spPr>
          <a:xfrm>
            <a:off x="4777093" y="3489959"/>
            <a:ext cx="1685290" cy="1093056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ivation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perone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ystem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ular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ress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ponse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" name="Textfeld 13">
            <a:extLst>
              <a:ext uri="{FF2B5EF4-FFF2-40B4-BE49-F238E27FC236}">
                <a16:creationId xmlns:a16="http://schemas.microsoft.com/office/drawing/2014/main" id="{A45EA9BB-5A64-4548-AC60-ED9F4F25FDDB}"/>
              </a:ext>
            </a:extLst>
          </p:cNvPr>
          <p:cNvSpPr txBox="1"/>
          <p:nvPr/>
        </p:nvSpPr>
        <p:spPr>
          <a:xfrm>
            <a:off x="4751036" y="5222765"/>
            <a:ext cx="1685290" cy="1727797"/>
          </a:xfrm>
          <a:prstGeom prst="round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longed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cessing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lding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s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ected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R-Golgi stress (i.a. DGC </a:t>
            </a:r>
            <a:r>
              <a:rPr lang="de-DE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s</a:t>
            </a:r>
            <a:r>
              <a: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F7F39EA2-90A9-4D62-ABA7-89536A5FD3DF}"/>
              </a:ext>
            </a:extLst>
          </p:cNvPr>
          <p:cNvCxnSpPr>
            <a:cxnSpLocks/>
          </p:cNvCxnSpPr>
          <p:nvPr/>
        </p:nvCxnSpPr>
        <p:spPr>
          <a:xfrm>
            <a:off x="5593681" y="4593905"/>
            <a:ext cx="0" cy="60261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Verbinder: gewinkelt 3">
            <a:extLst>
              <a:ext uri="{FF2B5EF4-FFF2-40B4-BE49-F238E27FC236}">
                <a16:creationId xmlns:a16="http://schemas.microsoft.com/office/drawing/2014/main" id="{77B9FAB1-596F-47DF-929C-E8BA5BD9A867}"/>
              </a:ext>
            </a:extLst>
          </p:cNvPr>
          <p:cNvCxnSpPr>
            <a:cxnSpLocks/>
          </p:cNvCxnSpPr>
          <p:nvPr/>
        </p:nvCxnSpPr>
        <p:spPr>
          <a:xfrm rot="16200000" flipV="1">
            <a:off x="1110462" y="4825707"/>
            <a:ext cx="2818284" cy="1431425"/>
          </a:xfrm>
          <a:prstGeom prst="bentConnector3">
            <a:avLst>
              <a:gd name="adj1" fmla="val -9670"/>
            </a:avLst>
          </a:prstGeom>
          <a:ln>
            <a:prstDash val="dash"/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Verbinder: gewinkelt 33">
            <a:extLst>
              <a:ext uri="{FF2B5EF4-FFF2-40B4-BE49-F238E27FC236}">
                <a16:creationId xmlns:a16="http://schemas.microsoft.com/office/drawing/2014/main" id="{13F68208-CBC4-4282-88C6-45416C3FEE7A}"/>
              </a:ext>
            </a:extLst>
          </p:cNvPr>
          <p:cNvCxnSpPr>
            <a:cxnSpLocks/>
            <a:stCxn id="32" idx="2"/>
          </p:cNvCxnSpPr>
          <p:nvPr/>
        </p:nvCxnSpPr>
        <p:spPr>
          <a:xfrm rot="5400000" flipH="1">
            <a:off x="2183801" y="3540682"/>
            <a:ext cx="2823532" cy="3996228"/>
          </a:xfrm>
          <a:prstGeom prst="bentConnector4">
            <a:avLst>
              <a:gd name="adj1" fmla="val -14796"/>
              <a:gd name="adj2" fmla="val 99994"/>
            </a:avLst>
          </a:prstGeom>
          <a:ln>
            <a:prstDash val="dash"/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2495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7</Words>
  <Application>Microsoft Office PowerPoint</Application>
  <PresentationFormat>Breit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Roos</dc:creator>
  <cp:lastModifiedBy>Andreas Roos</cp:lastModifiedBy>
  <cp:revision>146</cp:revision>
  <dcterms:created xsi:type="dcterms:W3CDTF">2016-02-20T23:50:36Z</dcterms:created>
  <dcterms:modified xsi:type="dcterms:W3CDTF">2018-06-03T20:26:22Z</dcterms:modified>
</cp:coreProperties>
</file>